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6" r:id="rId2"/>
    <p:sldId id="256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460"/>
    <p:restoredTop sz="94724"/>
  </p:normalViewPr>
  <p:slideViewPr>
    <p:cSldViewPr snapToGrid="0" snapToObjects="1">
      <p:cViewPr varScale="1">
        <p:scale>
          <a:sx n="98" d="100"/>
          <a:sy n="98" d="100"/>
        </p:scale>
        <p:origin x="208" y="3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2566FA7-0328-B540-ABC9-DA9254B73A1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31DEBB7F-F849-EA4C-9635-8A3EC2B90B8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505FDAC-F33C-394D-90F2-12072ECEA2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BBC0B-B6FD-FB4B-8769-C044438D51A1}" type="datetimeFigureOut">
              <a:rPr lang="fr-FR" smtClean="0"/>
              <a:t>1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A366B28-8F1F-F243-B03C-0D06B2EE68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B42A2A5-185C-AE4B-B582-363116CEB1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63953-E308-7F4F-84FF-C84D7AB0FC7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48269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D47DA35-D96B-B043-A1AE-B9F121828B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260D5F05-FD8F-5647-A969-95DD6ACD44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7E6034B-6675-B74B-BB74-E672CC9A86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BBC0B-B6FD-FB4B-8769-C044438D51A1}" type="datetimeFigureOut">
              <a:rPr lang="fr-FR" smtClean="0"/>
              <a:t>1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65AA8FD-2664-9241-97E8-4EC3D4604C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C2A0C23-3D3B-2647-8364-DF119DE1CC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63953-E308-7F4F-84FF-C84D7AB0FC7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68425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38C70461-E5C2-FF44-AE69-A00071FC540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41667FDC-476E-4A4B-8963-451BBD199A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FAD8FE3-16B8-7C4A-96CE-3BBB496192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BBC0B-B6FD-FB4B-8769-C044438D51A1}" type="datetimeFigureOut">
              <a:rPr lang="fr-FR" smtClean="0"/>
              <a:t>1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681046F-5242-8342-A86A-14AC861FD4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29BD18C-4FBE-BC43-A600-11B5094422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63953-E308-7F4F-84FF-C84D7AB0FC7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14858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CCFA786-BA85-6F4B-B82C-39C5C73365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7320E44-AF1A-2545-A8BE-520684D2C5E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607A353-BBBB-784F-8DB4-9D18311B6D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BBC0B-B6FD-FB4B-8769-C044438D51A1}" type="datetimeFigureOut">
              <a:rPr lang="fr-FR" smtClean="0"/>
              <a:t>1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37791CA-93A8-6A42-9E08-B80384392F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B4C5908-F55D-7341-BC55-93867F355F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63953-E308-7F4F-84FF-C84D7AB0FC7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649003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1E4539D-F426-6E44-9685-5008D07919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B6DB867-AFC1-6A49-AF4B-26C809FEA6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45B3D48-A2B7-2A4F-9829-2D394842DA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BBC0B-B6FD-FB4B-8769-C044438D51A1}" type="datetimeFigureOut">
              <a:rPr lang="fr-FR" smtClean="0"/>
              <a:t>1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6F55D39-021A-DD4C-A7F7-4CB9632ADE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D8CEC62-429D-9F44-B54C-FE510B4929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63953-E308-7F4F-84FF-C84D7AB0FC7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568049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B1BB4F7-05E7-354E-B697-6E93B1F20A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956FEEF5-3173-1140-A066-70119895E53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615315A-783F-6148-879B-9532D4CD9F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059A5B22-F7F1-3D45-BFE6-A8E5BF3E21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BBC0B-B6FD-FB4B-8769-C044438D51A1}" type="datetimeFigureOut">
              <a:rPr lang="fr-FR" smtClean="0"/>
              <a:t>17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7EC64D94-424D-124E-AC36-B6F6D1EFAE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2865F67-4F1D-4B4C-B36B-2680E3D647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63953-E308-7F4F-84FF-C84D7AB0FC7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082483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D741A2A-6E91-8449-8E80-9CEE421611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32DFEF7A-9DB4-4240-BEDF-5C95DEAC4C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A8AAF2DB-F85B-DD43-9DF8-EDAAF05867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344A4A35-E8B3-AB4A-A703-6874FF8FCF3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1CB75915-19C2-B747-AFCC-EBCF544B62C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C9EDE4D8-9CA5-DC44-8709-FA7AE16FF3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BBC0B-B6FD-FB4B-8769-C044438D51A1}" type="datetimeFigureOut">
              <a:rPr lang="fr-FR" smtClean="0"/>
              <a:t>17/05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35435827-1D92-0A45-8199-7154906B52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4393DB5D-C861-7043-B4C5-BFD4ED484B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63953-E308-7F4F-84FF-C84D7AB0FC7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73714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D98109B-0117-6C4B-B4CC-FA0AC15BE8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533518C4-FA48-B745-A62D-41BFAF0BF0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BBC0B-B6FD-FB4B-8769-C044438D51A1}" type="datetimeFigureOut">
              <a:rPr lang="fr-FR" smtClean="0"/>
              <a:t>17/05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4C35B2BD-3A37-4C4D-A64C-C8E402E481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987F3380-953C-2D4C-BB41-3A72C3AAF7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63953-E308-7F4F-84FF-C84D7AB0FC7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362795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ED51E300-A8A6-8A48-A788-7455925426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BBC0B-B6FD-FB4B-8769-C044438D51A1}" type="datetimeFigureOut">
              <a:rPr lang="fr-FR" smtClean="0"/>
              <a:t>17/05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33DFD063-278F-D545-A58C-738D7AB72B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A454F517-8C6E-674D-A4F1-75E8122E40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63953-E308-7F4F-84FF-C84D7AB0FC7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85977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D45E796-F90D-B742-9F3F-232B85DB07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FC92BBF-FDC6-3C46-B9F1-7BA1022B080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C66234B0-B30B-E647-B814-2498DF2980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0878C8DF-F259-F043-B27C-2D854C4044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BBC0B-B6FD-FB4B-8769-C044438D51A1}" type="datetimeFigureOut">
              <a:rPr lang="fr-FR" smtClean="0"/>
              <a:t>17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4ED42382-3EDF-9249-A6CF-469F3F18CA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23274472-0F05-6046-ADF4-55CC2B973E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63953-E308-7F4F-84FF-C84D7AB0FC7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709979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D310A6C-175E-274E-B736-BFE96622F2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C1CDB6A6-48EE-7946-AACF-62982DED626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8B99E91-EBEA-BD4B-862A-03C966ADC1C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9903AAB9-5B93-5747-91BF-FCDB86106C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BBC0B-B6FD-FB4B-8769-C044438D51A1}" type="datetimeFigureOut">
              <a:rPr lang="fr-FR" smtClean="0"/>
              <a:t>17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AC3962D-231E-834C-87A7-92B940F8BC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27AE54A-8E0E-1F43-B742-89C782EEE7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63953-E308-7F4F-84FF-C84D7AB0FC7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68881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0AE292AE-DA31-954C-A0B6-AB38E59924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B9F0DE9-FCB7-DB46-BF96-C64D996618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8E90279-85C9-7648-BFAA-BC93A786EA7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CBBC0B-B6FD-FB4B-8769-C044438D51A1}" type="datetimeFigureOut">
              <a:rPr lang="fr-FR" smtClean="0"/>
              <a:t>1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87CA5D6-BD06-9B43-8D1B-908FC514209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866D51F-ADA9-4C4A-91E4-1BB1368CB99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D63953-E308-7F4F-84FF-C84D7AB0FC7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934854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9E28644F-AD0D-A349-9378-E6345ABF0141}"/>
              </a:ext>
            </a:extLst>
          </p:cNvPr>
          <p:cNvSpPr txBox="1"/>
          <p:nvPr/>
        </p:nvSpPr>
        <p:spPr>
          <a:xfrm>
            <a:off x="0" y="0"/>
            <a:ext cx="121920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solidFill>
                  <a:srgbClr val="FF0000"/>
                </a:solidFill>
              </a:rPr>
              <a:t>Figure 7: PKC activation </a:t>
            </a:r>
            <a:r>
              <a:rPr lang="fr-FR" dirty="0" err="1">
                <a:solidFill>
                  <a:srgbClr val="FF0000"/>
                </a:solidFill>
              </a:rPr>
              <a:t>is</a:t>
            </a:r>
            <a:r>
              <a:rPr lang="fr-FR" dirty="0">
                <a:solidFill>
                  <a:srgbClr val="FF0000"/>
                </a:solidFill>
              </a:rPr>
              <a:t> a GPR101 signature </a:t>
            </a:r>
            <a:r>
              <a:rPr lang="fr-FR" i="1" dirty="0">
                <a:solidFill>
                  <a:srgbClr val="FF0000"/>
                </a:solidFill>
              </a:rPr>
              <a:t>in vivo</a:t>
            </a:r>
          </a:p>
          <a:p>
            <a:r>
              <a:rPr lang="fr-FR" dirty="0">
                <a:solidFill>
                  <a:srgbClr val="FF0000"/>
                </a:solidFill>
              </a:rPr>
              <a:t>Panel C: Immunofluorescence </a:t>
            </a:r>
            <a:r>
              <a:rPr lang="fr-FR" dirty="0" err="1">
                <a:solidFill>
                  <a:srgbClr val="FF0000"/>
                </a:solidFill>
              </a:rPr>
              <a:t>staining</a:t>
            </a:r>
            <a:r>
              <a:rPr lang="fr-FR" dirty="0">
                <a:solidFill>
                  <a:srgbClr val="FF0000"/>
                </a:solidFill>
              </a:rPr>
              <a:t> of </a:t>
            </a:r>
            <a:r>
              <a:rPr lang="fr-FR" dirty="0" err="1">
                <a:solidFill>
                  <a:srgbClr val="FF0000"/>
                </a:solidFill>
              </a:rPr>
              <a:t>Phospho</a:t>
            </a:r>
            <a:r>
              <a:rPr lang="fr-FR" dirty="0">
                <a:solidFill>
                  <a:srgbClr val="FF0000"/>
                </a:solidFill>
              </a:rPr>
              <a:t>-PKC alpha (Thr638) in </a:t>
            </a:r>
            <a:r>
              <a:rPr lang="fr-FR" dirty="0" err="1">
                <a:solidFill>
                  <a:srgbClr val="FF0000"/>
                </a:solidFill>
              </a:rPr>
              <a:t>pituitary</a:t>
            </a:r>
            <a:r>
              <a:rPr lang="fr-FR" dirty="0">
                <a:solidFill>
                  <a:srgbClr val="FF0000"/>
                </a:solidFill>
              </a:rPr>
              <a:t> sections of WT and </a:t>
            </a:r>
            <a:r>
              <a:rPr lang="fr-FR" i="1" dirty="0">
                <a:solidFill>
                  <a:srgbClr val="FF0000"/>
                </a:solidFill>
              </a:rPr>
              <a:t>Ghrhr</a:t>
            </a:r>
            <a:r>
              <a:rPr lang="fr-FR" baseline="30000" dirty="0">
                <a:solidFill>
                  <a:srgbClr val="FF0000"/>
                </a:solidFill>
              </a:rPr>
              <a:t>Gpr101</a:t>
            </a:r>
            <a:r>
              <a:rPr lang="fr-FR" dirty="0">
                <a:solidFill>
                  <a:srgbClr val="FF0000"/>
                </a:solidFill>
              </a:rPr>
              <a:t> </a:t>
            </a:r>
            <a:r>
              <a:rPr lang="fr-FR" dirty="0" err="1">
                <a:solidFill>
                  <a:srgbClr val="FF0000"/>
                </a:solidFill>
              </a:rPr>
              <a:t>mice</a:t>
            </a:r>
            <a:r>
              <a:rPr lang="fr-FR" dirty="0">
                <a:solidFill>
                  <a:srgbClr val="FF0000"/>
                </a:solidFill>
              </a:rPr>
              <a:t> </a:t>
            </a:r>
          </a:p>
          <a:p>
            <a:pPr marL="285750" indent="-285750">
              <a:buFontTx/>
              <a:buChar char="-"/>
            </a:pPr>
            <a:r>
              <a:rPr lang="fr-FR" dirty="0"/>
              <a:t>Males, </a:t>
            </a:r>
            <a:r>
              <a:rPr lang="fr-FR" dirty="0" err="1"/>
              <a:t>age</a:t>
            </a:r>
            <a:r>
              <a:rPr lang="fr-FR" dirty="0"/>
              <a:t>: 29-week </a:t>
            </a:r>
            <a:r>
              <a:rPr lang="fr-FR" dirty="0" err="1"/>
              <a:t>old</a:t>
            </a:r>
            <a:endParaRPr lang="fr-FR" dirty="0"/>
          </a:p>
          <a:p>
            <a:pPr marL="285750" indent="-285750">
              <a:buFontTx/>
              <a:buChar char="-"/>
            </a:pPr>
            <a:r>
              <a:rPr lang="fr-FR" dirty="0"/>
              <a:t>n= 4 </a:t>
            </a:r>
            <a:r>
              <a:rPr lang="fr-FR" dirty="0" err="1"/>
              <a:t>mice</a:t>
            </a:r>
            <a:r>
              <a:rPr lang="fr-FR" dirty="0"/>
              <a:t>/group</a:t>
            </a:r>
          </a:p>
          <a:p>
            <a:pPr marL="285750" indent="-285750">
              <a:buFontTx/>
              <a:buChar char="-"/>
            </a:pPr>
            <a:r>
              <a:rPr lang="fr-FR" dirty="0"/>
              <a:t>Photos </a:t>
            </a:r>
            <a:r>
              <a:rPr lang="fr-FR" dirty="0" err="1"/>
              <a:t>were</a:t>
            </a:r>
            <a:r>
              <a:rPr lang="fr-FR" dirty="0"/>
              <a:t> </a:t>
            </a:r>
            <a:r>
              <a:rPr lang="fr-FR" dirty="0" err="1"/>
              <a:t>taken</a:t>
            </a:r>
            <a:r>
              <a:rPr lang="fr-FR" dirty="0"/>
              <a:t> at x60 magnification (Nikon A1R microscope)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D0B5F70A-512F-994D-8A0A-55F59DF88BCA}"/>
              </a:ext>
            </a:extLst>
          </p:cNvPr>
          <p:cNvSpPr txBox="1"/>
          <p:nvPr/>
        </p:nvSpPr>
        <p:spPr>
          <a:xfrm>
            <a:off x="368301" y="3441700"/>
            <a:ext cx="6756399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>
                <a:solidFill>
                  <a:srgbClr val="FF0000"/>
                </a:solidFill>
              </a:rPr>
              <a:t>For the detection of phospho-PKC alpha:</a:t>
            </a:r>
          </a:p>
          <a:p>
            <a:pPr marL="285750" indent="-285750">
              <a:buFontTx/>
              <a:buChar char="-"/>
            </a:pPr>
            <a:r>
              <a:rPr lang="en-US" dirty="0">
                <a:solidFill>
                  <a:srgbClr val="FF0000"/>
                </a:solidFill>
              </a:rPr>
              <a:t>Primary antibody: anti-phospho-PKC alpha (Thr638) rabbit polyclonal antibody (Life Technologies, Cat. No 44-962G, dilution 1:500)</a:t>
            </a:r>
          </a:p>
          <a:p>
            <a:pPr marL="285750" indent="-285750">
              <a:buFontTx/>
              <a:buChar char="-"/>
            </a:pPr>
            <a:r>
              <a:rPr lang="en-US" dirty="0">
                <a:solidFill>
                  <a:srgbClr val="FF0000"/>
                </a:solidFill>
              </a:rPr>
              <a:t>Secondary antibody: anti-rabbit IgG Fab2 Alexa Fluor 647 (Cell Signaling Technology, Cat. No 4414S, dilution 1:1000)</a:t>
            </a:r>
            <a:r>
              <a:rPr lang="fr-BE" dirty="0">
                <a:solidFill>
                  <a:srgbClr val="FF0000"/>
                </a:solidFill>
              </a:rPr>
              <a:t> </a:t>
            </a:r>
            <a:endParaRPr lang="fr-FR" dirty="0">
              <a:solidFill>
                <a:srgbClr val="FF0000"/>
              </a:solidFill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1C5173E5-F9F3-194E-9884-B045842D533C}"/>
              </a:ext>
            </a:extLst>
          </p:cNvPr>
          <p:cNvSpPr txBox="1"/>
          <p:nvPr/>
        </p:nvSpPr>
        <p:spPr>
          <a:xfrm>
            <a:off x="368301" y="2527300"/>
            <a:ext cx="276466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u="sng" dirty="0">
                <a:solidFill>
                  <a:srgbClr val="00B0F0"/>
                </a:solidFill>
              </a:rPr>
              <a:t>For the </a:t>
            </a:r>
            <a:r>
              <a:rPr lang="fr-FR" b="1" u="sng" dirty="0" err="1">
                <a:solidFill>
                  <a:srgbClr val="00B0F0"/>
                </a:solidFill>
              </a:rPr>
              <a:t>detection</a:t>
            </a:r>
            <a:r>
              <a:rPr lang="fr-FR" b="1" u="sng" dirty="0">
                <a:solidFill>
                  <a:srgbClr val="00B0F0"/>
                </a:solidFill>
              </a:rPr>
              <a:t> of </a:t>
            </a:r>
            <a:r>
              <a:rPr lang="fr-FR" b="1" u="sng" dirty="0" err="1">
                <a:solidFill>
                  <a:srgbClr val="00B0F0"/>
                </a:solidFill>
              </a:rPr>
              <a:t>nuclei</a:t>
            </a:r>
            <a:r>
              <a:rPr lang="fr-FR" b="1" u="sng" dirty="0">
                <a:solidFill>
                  <a:srgbClr val="00B0F0"/>
                </a:solidFill>
              </a:rPr>
              <a:t>:</a:t>
            </a:r>
          </a:p>
          <a:p>
            <a:r>
              <a:rPr lang="fr-FR" dirty="0">
                <a:solidFill>
                  <a:srgbClr val="00B0F0"/>
                </a:solidFill>
              </a:rPr>
              <a:t>DAPI</a:t>
            </a:r>
          </a:p>
        </p:txBody>
      </p:sp>
    </p:spTree>
    <p:extLst>
      <p:ext uri="{BB962C8B-B14F-4D97-AF65-F5344CB8AC3E}">
        <p14:creationId xmlns:p14="http://schemas.microsoft.com/office/powerpoint/2010/main" val="12580344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5F2A5111-AA86-9C40-B136-F2A8758EFCC2}"/>
              </a:ext>
            </a:extLst>
          </p:cNvPr>
          <p:cNvPicPr>
            <a:picLocks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8848939" y="3461246"/>
            <a:ext cx="3240000" cy="3240000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552E9C54-5B1C-CD4D-A8BD-DAAB94FBEDC3}"/>
              </a:ext>
            </a:extLst>
          </p:cNvPr>
          <p:cNvPicPr>
            <a:picLocks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063799" y="3461246"/>
            <a:ext cx="3240000" cy="3240000"/>
          </a:xfrm>
          <a:prstGeom prst="rect">
            <a:avLst/>
          </a:prstGeom>
        </p:spPr>
      </p:pic>
      <p:pic>
        <p:nvPicPr>
          <p:cNvPr id="9" name="Image 8">
            <a:extLst>
              <a:ext uri="{FF2B5EF4-FFF2-40B4-BE49-F238E27FC236}">
                <a16:creationId xmlns:a16="http://schemas.microsoft.com/office/drawing/2014/main" id="{DC659AF0-F089-154D-A9AC-E96CA24864A9}"/>
              </a:ext>
            </a:extLst>
          </p:cNvPr>
          <p:cNvPicPr>
            <a:picLocks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456369" y="3461246"/>
            <a:ext cx="3240000" cy="3240000"/>
          </a:xfrm>
          <a:prstGeom prst="rect">
            <a:avLst/>
          </a:prstGeom>
        </p:spPr>
      </p:pic>
      <p:pic>
        <p:nvPicPr>
          <p:cNvPr id="11" name="Image 10">
            <a:extLst>
              <a:ext uri="{FF2B5EF4-FFF2-40B4-BE49-F238E27FC236}">
                <a16:creationId xmlns:a16="http://schemas.microsoft.com/office/drawing/2014/main" id="{54281EED-66F1-394F-A476-EED01F8141C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8848939" y="137531"/>
            <a:ext cx="3240000" cy="3240000"/>
          </a:xfrm>
          <a:prstGeom prst="rect">
            <a:avLst/>
          </a:prstGeom>
        </p:spPr>
      </p:pic>
      <p:pic>
        <p:nvPicPr>
          <p:cNvPr id="13" name="Image 12">
            <a:extLst>
              <a:ext uri="{FF2B5EF4-FFF2-40B4-BE49-F238E27FC236}">
                <a16:creationId xmlns:a16="http://schemas.microsoft.com/office/drawing/2014/main" id="{32F501E7-1475-FA4D-90AA-871B4E3F8A8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063799" y="137531"/>
            <a:ext cx="3240000" cy="3240000"/>
          </a:xfrm>
          <a:prstGeom prst="rect">
            <a:avLst/>
          </a:prstGeom>
        </p:spPr>
      </p:pic>
      <p:pic>
        <p:nvPicPr>
          <p:cNvPr id="15" name="Image 14">
            <a:extLst>
              <a:ext uri="{FF2B5EF4-FFF2-40B4-BE49-F238E27FC236}">
                <a16:creationId xmlns:a16="http://schemas.microsoft.com/office/drawing/2014/main" id="{7ED70586-A250-AC42-B115-7A7C576CFA1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456369" y="137531"/>
            <a:ext cx="3240000" cy="3240000"/>
          </a:xfrm>
          <a:prstGeom prst="rect">
            <a:avLst/>
          </a:prstGeom>
        </p:spPr>
      </p:pic>
      <p:sp>
        <p:nvSpPr>
          <p:cNvPr id="16" name="ZoneTexte 15">
            <a:extLst>
              <a:ext uri="{FF2B5EF4-FFF2-40B4-BE49-F238E27FC236}">
                <a16:creationId xmlns:a16="http://schemas.microsoft.com/office/drawing/2014/main" id="{9D68B0EF-EA1E-8848-90DD-745D6BA43A91}"/>
              </a:ext>
            </a:extLst>
          </p:cNvPr>
          <p:cNvSpPr txBox="1"/>
          <p:nvPr/>
        </p:nvSpPr>
        <p:spPr>
          <a:xfrm>
            <a:off x="188286" y="1349406"/>
            <a:ext cx="189026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Mouse </a:t>
            </a:r>
            <a:r>
              <a:rPr lang="fr-FR" b="1" dirty="0" err="1">
                <a:latin typeface="Arial" panose="020B0604020202020204" pitchFamily="34" charset="0"/>
                <a:cs typeface="Arial" panose="020B0604020202020204" pitchFamily="34" charset="0"/>
              </a:rPr>
              <a:t>pituitary</a:t>
            </a:r>
            <a:endParaRPr lang="fr-FR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29D18FC6-F8ED-1B46-B933-3852197F9257}"/>
              </a:ext>
            </a:extLst>
          </p:cNvPr>
          <p:cNvSpPr txBox="1"/>
          <p:nvPr/>
        </p:nvSpPr>
        <p:spPr>
          <a:xfrm>
            <a:off x="2078547" y="152279"/>
            <a:ext cx="98490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1BD4535C-163E-1440-81AC-C896F832C49A}"/>
              </a:ext>
            </a:extLst>
          </p:cNvPr>
          <p:cNvSpPr txBox="1"/>
          <p:nvPr/>
        </p:nvSpPr>
        <p:spPr>
          <a:xfrm>
            <a:off x="2063799" y="3461246"/>
            <a:ext cx="98490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5D850BB8-FA62-794F-A741-5D84E2D0ACAA}"/>
              </a:ext>
            </a:extLst>
          </p:cNvPr>
          <p:cNvSpPr txBox="1"/>
          <p:nvPr/>
        </p:nvSpPr>
        <p:spPr>
          <a:xfrm>
            <a:off x="8848939" y="152279"/>
            <a:ext cx="3240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fr-FR" sz="2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DD7CFB0F-FACC-6141-BCF9-7B90EFCAACEF}"/>
              </a:ext>
            </a:extLst>
          </p:cNvPr>
          <p:cNvSpPr txBox="1"/>
          <p:nvPr/>
        </p:nvSpPr>
        <p:spPr>
          <a:xfrm>
            <a:off x="8848939" y="3480767"/>
            <a:ext cx="3240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fr-FR" sz="2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7FC1A03E-42BF-514F-986A-418ACF9E6184}"/>
              </a:ext>
            </a:extLst>
          </p:cNvPr>
          <p:cNvSpPr txBox="1"/>
          <p:nvPr/>
        </p:nvSpPr>
        <p:spPr>
          <a:xfrm>
            <a:off x="97253" y="4758080"/>
            <a:ext cx="189026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Mouse </a:t>
            </a:r>
            <a:r>
              <a:rPr lang="fr-FR" b="1" dirty="0" err="1">
                <a:latin typeface="Arial" panose="020B0604020202020204" pitchFamily="34" charset="0"/>
                <a:cs typeface="Arial" panose="020B0604020202020204" pitchFamily="34" charset="0"/>
              </a:rPr>
              <a:t>pituitary</a:t>
            </a:r>
            <a:endParaRPr lang="fr-FR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+/</a:t>
            </a:r>
            <a:r>
              <a:rPr lang="fr-FR" b="1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fr-F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A388B4DF-EC77-CD49-97C0-0A53D095C89F}"/>
              </a:ext>
            </a:extLst>
          </p:cNvPr>
          <p:cNvSpPr/>
          <p:nvPr/>
        </p:nvSpPr>
        <p:spPr>
          <a:xfrm>
            <a:off x="0" y="6488668"/>
            <a:ext cx="17440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/>
              <a:t>Scale</a:t>
            </a:r>
            <a:r>
              <a:rPr lang="fr-FR" dirty="0"/>
              <a:t> bar= 10µm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6B948863-3509-4049-92F5-5E37BCC73C98}"/>
              </a:ext>
            </a:extLst>
          </p:cNvPr>
          <p:cNvSpPr txBox="1"/>
          <p:nvPr/>
        </p:nvSpPr>
        <p:spPr>
          <a:xfrm>
            <a:off x="5465428" y="158364"/>
            <a:ext cx="3195755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ospho</a:t>
            </a:r>
            <a:r>
              <a:rPr lang="fr-FR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PKC </a:t>
            </a:r>
            <a:r>
              <a:rPr lang="fr-FR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ɒ</a:t>
            </a:r>
            <a:endParaRPr lang="fr-FR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Thr638)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B868E6FA-DED0-2E4F-B2FD-A85E71EB5003}"/>
              </a:ext>
            </a:extLst>
          </p:cNvPr>
          <p:cNvSpPr txBox="1"/>
          <p:nvPr/>
        </p:nvSpPr>
        <p:spPr>
          <a:xfrm>
            <a:off x="5456369" y="3473789"/>
            <a:ext cx="3195755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ospho</a:t>
            </a:r>
            <a:r>
              <a:rPr lang="fr-FR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PKC </a:t>
            </a:r>
            <a:r>
              <a:rPr lang="fr-FR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ɒ</a:t>
            </a:r>
            <a:endParaRPr lang="fr-FR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Thr638)</a:t>
            </a:r>
          </a:p>
        </p:txBody>
      </p:sp>
    </p:spTree>
    <p:extLst>
      <p:ext uri="{BB962C8B-B14F-4D97-AF65-F5344CB8AC3E}">
        <p14:creationId xmlns:p14="http://schemas.microsoft.com/office/powerpoint/2010/main" val="257000226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7</TotalTime>
  <Words>137</Words>
  <Application>Microsoft Macintosh PowerPoint</Application>
  <PresentationFormat>Grand écran</PresentationFormat>
  <Paragraphs>23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Microsoft Office</dc:creator>
  <cp:lastModifiedBy>Utilisateur Microsoft Office</cp:lastModifiedBy>
  <cp:revision>4</cp:revision>
  <dcterms:created xsi:type="dcterms:W3CDTF">2019-04-23T07:08:33Z</dcterms:created>
  <dcterms:modified xsi:type="dcterms:W3CDTF">2020-05-17T15:37:11Z</dcterms:modified>
</cp:coreProperties>
</file>